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80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565E30-F684-480F-1F99-56B26950A43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695A189-79AE-9D61-A10F-7B286AC4002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E3A8D0-AC03-DAAC-2BEC-410E34C3C7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FC30D0-B629-4F12-37CB-B45EAE30E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60E194-17E9-CA3C-1908-D0813FD8CE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42572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049BD2-FEFB-44FA-D67C-74332073F4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F9A5090-C4F9-703C-5C64-B081E66C5B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CD5AAC-A80A-5DCD-528A-C81B052DAB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73D576-8A85-E5CB-1EB9-646A7ED63B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C3C23A-41DC-9E6D-6F7D-ED7A7A25C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89671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0C2D50D-C404-7D06-8FB6-0AA9706C81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2C9190-DE81-3F30-6D97-F10AA64009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B6C906-E620-D6EF-4D1C-56DBDFAC05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913E96-0EB7-08AC-9D2D-BF97D1D71D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DA8DF9-75CE-00A6-1E97-105EBFCEC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4815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2E7D9A-0734-5286-AC31-26596EDA7A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847ACB-660C-DDD8-ADA8-3882F23D5BC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653AB8-7E56-E14F-E10C-FA45860B79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A176B1-F28A-3A21-D227-AAC25B9C33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891964-0952-AD48-DDCA-A0F3551E79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1855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D0D7D2-225D-6789-9F86-3FD8F4CDCB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C3B4EC-720F-FF56-535A-890EFC339D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33AD8A-BA26-9236-B8A4-6098941542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F484D4-63FC-688F-BC3B-E1BB58CAB4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F5FEA0-B735-1531-284A-F537D6744A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44058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01F766-AD65-9C49-8070-D5458FE592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669D10-4E53-A17D-4016-F6353E6BCFE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51B119-C18E-6AD1-516F-9337E34F7D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8F3682-3097-5530-731B-9CFCC77884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ECE13A-BD62-40FC-65F7-8FA44B979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86F80F8-C052-5AD3-1353-E078441EC9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97836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09B22E-F418-A800-09A3-77ADBDE79B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4C05F8-19FD-8D50-F665-908453C524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86FB67F-C695-C57F-958A-5A1464DAFA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43D4D57-F9E5-1DA7-F65E-AC4A6BCA6F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795B8B6-6AAE-468D-5C88-1F5B025357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7A2D9D4-8325-27A7-3541-7B84348300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516B69E-E342-A574-4AB9-2575F87023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BE48DEB-4E1A-F736-9DB1-9A4937BCA7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0949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2E86E3-9438-37FF-C38D-A9CB0B45E9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AE34B7D-EB56-EFFA-B95A-A1E7F410E3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8A8C936-3879-8D8C-F99C-E12CC75CFB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4A124B9-40CE-136C-C085-4DE4083FC2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6261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51116C8-EC8B-490C-0A84-F49AEA0E0F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C28EB5B-306E-99AB-63B0-D70296A22B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423E1DA-6243-F878-5804-1C7B3A0F67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31584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C59B1E-37A6-3B73-3935-C6F807D71A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51118D-58AD-FA97-F53B-01C003AF33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934501-E92E-F275-DE1F-394D4C4BA2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9323E7-D06D-8674-0EB9-6E5532B214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DF9764-6402-A4BB-07E8-E20737D991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C889D4-045A-549D-D8A2-7303991609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63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DC3F73-E8A1-EBD9-BCA5-22DC577563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C8AC5F7-C601-813F-3DB0-07FFEACE42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9EB6F8-78BB-0726-D573-F0C2E4D019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8445CE-B232-F188-1DC7-B6F55F50CF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03D3D9-D68F-FA0E-7BB9-39615F2597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F9DB0C-F0B1-5FF7-7D9D-2E0D6B66ED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0452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274B621-918B-07FD-15CC-22EA9B8F4B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209415-7881-DB15-5DE8-80CB7FC8F9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4C0C59-D95F-DF0D-9DB1-6AA5492C13D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5071E3-339F-E7C3-02B2-FEA33DB4F5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5AF9DF-F0B5-09A2-AD6D-FFA3C319D19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72837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phic 5">
            <a:extLst>
              <a:ext uri="{FF2B5EF4-FFF2-40B4-BE49-F238E27FC236}">
                <a16:creationId xmlns:a16="http://schemas.microsoft.com/office/drawing/2014/main" id="{9B4D5B65-C492-E70D-935E-21E26A82F40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52248"/>
          <a:stretch/>
        </p:blipFill>
        <p:spPr>
          <a:xfrm>
            <a:off x="6309360" y="436880"/>
            <a:ext cx="4532006" cy="47244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844F4153-3C27-DE68-9CCA-4461944374BF}"/>
              </a:ext>
            </a:extLst>
          </p:cNvPr>
          <p:cNvSpPr txBox="1"/>
          <p:nvPr/>
        </p:nvSpPr>
        <p:spPr>
          <a:xfrm>
            <a:off x="863600" y="5466080"/>
            <a:ext cx="1046480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ure  S5.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stribution of the size of the largest connected component of the differentially abundant proteins in the human Protein-Protein Interactions Network at 0.01uM (blue), 0.1uM (green), 1uM (red) BPA concentrations against 10,000 random protein sets of the same size.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r chart representing the number of interactions among the differentially abundant proteins for each BPA-treated group, distinguishing global signature (green), up-regulated proteins (red), and down-regulated proteins (blue). </a:t>
            </a:r>
          </a:p>
        </p:txBody>
      </p:sp>
      <p:pic>
        <p:nvPicPr>
          <p:cNvPr id="5" name="Graphic 4">
            <a:extLst>
              <a:ext uri="{FF2B5EF4-FFF2-40B4-BE49-F238E27FC236}">
                <a16:creationId xmlns:a16="http://schemas.microsoft.com/office/drawing/2014/main" id="{6DCB10FC-3897-7B65-4D01-B52A15BA055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044788" y="436880"/>
            <a:ext cx="4961466" cy="51077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63680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</TotalTime>
  <Words>9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</dc:creator>
  <cp:lastModifiedBy>Alex</cp:lastModifiedBy>
  <cp:revision>8</cp:revision>
  <dcterms:created xsi:type="dcterms:W3CDTF">2023-04-17T16:06:37Z</dcterms:created>
  <dcterms:modified xsi:type="dcterms:W3CDTF">2023-08-05T14:28:46Z</dcterms:modified>
</cp:coreProperties>
</file>